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332" r:id="rId5"/>
    <p:sldId id="265" r:id="rId6"/>
    <p:sldId id="316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99"/>
    <a:srgbClr val="0000FF"/>
    <a:srgbClr val="700070"/>
    <a:srgbClr val="CC3399"/>
    <a:srgbClr val="66FFFF"/>
    <a:srgbClr val="99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2E7B1BD-7D5E-438A-9687-B84029060B70}" v="1" dt="2022-10-06T14:41:05.53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2858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11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2827D5-B39A-46A9-80D9-98FEC10885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25D84DB-3900-4FF1-9BE9-CB785A7E202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A0874E-1A88-41D4-95BE-2E178F10D2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15B7C-E7FE-403B-803B-159376EDE386}" type="datetimeFigureOut">
              <a:rPr lang="en-US" smtClean="0"/>
              <a:t>10/15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32E97D-8677-47F9-8A4F-69CB8B7FA8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639C2C-ABE2-472E-83E6-0C9D397E82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2C32-8ACE-48A5-8DCA-DCA24D225D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5435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17A536-DE36-44B3-AAD8-A2C7655C1A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CF9332-1B6A-4811-B2DA-7862A5CB00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94B521-7E0D-4368-A013-2735EB2AF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15B7C-E7FE-403B-803B-159376EDE386}" type="datetimeFigureOut">
              <a:rPr lang="en-US" smtClean="0"/>
              <a:t>10/15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3FCF3D-CA8B-4F70-87A1-0B31615B0F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C7E8ED-96A5-4FB5-98B5-F7FE24CBEA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2C32-8ACE-48A5-8DCA-DCA24D225D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1486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E83E4B5-8A08-41BB-B16E-8249A466C0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97A58C-21AD-461E-A2E4-4955974A74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C410FC-7558-4527-BF24-520F2CC767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15B7C-E7FE-403B-803B-159376EDE386}" type="datetimeFigureOut">
              <a:rPr lang="en-US" smtClean="0"/>
              <a:t>10/15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4114E6-7229-4A73-8AB9-A310B40295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0F77A2-C339-445C-B2B2-C5651DEA7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2C32-8ACE-48A5-8DCA-DCA24D225D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2718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2A731C-9045-4CBB-9611-B82DB326B0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17D5C9-0B1D-4CBB-AFB1-D32ED13207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4DC468-4CC0-441C-BB69-3709CC8718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15B7C-E7FE-403B-803B-159376EDE386}" type="datetimeFigureOut">
              <a:rPr lang="en-US" smtClean="0"/>
              <a:t>10/15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E2DF90-1171-4676-BE0F-8E29E97FD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B9DDBB-0268-4E69-AA74-02E356B06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2C32-8ACE-48A5-8DCA-DCA24D225D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59676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3C54D1-14FF-4379-AA45-89070F5FBE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816C79-21B2-4BA1-A24A-94CBCE5929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8ACF07-6FF5-4CC8-8199-1536E060B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15B7C-E7FE-403B-803B-159376EDE386}" type="datetimeFigureOut">
              <a:rPr lang="en-US" smtClean="0"/>
              <a:t>10/15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185B36-C062-4107-B56D-9F4085B04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33C1C0-21C4-48C2-8AC3-E58E0CCFE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2C32-8ACE-48A5-8DCA-DCA24D225D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6796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B32FBE-8834-4E32-9D91-02C4FB5727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DA76D9-E49F-4E8D-9068-ED31FF6B6B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25941E-4962-493B-8219-79DE4A7E50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D8BD8D-9079-422D-84A2-D1F8FE6936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15B7C-E7FE-403B-803B-159376EDE386}" type="datetimeFigureOut">
              <a:rPr lang="en-US" smtClean="0"/>
              <a:t>10/15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848BBA-8A1E-4DDA-9150-92DFCFCDFE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A1FA60-9374-4985-BEC8-4AE5B5930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2C32-8ACE-48A5-8DCA-DCA24D225D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93201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534B4F-4DCA-45E2-AF6D-0AA61F32B5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1A5864-A19F-448A-A4A6-0679E3274C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5EF80F-1F4E-42C4-A9ED-9F05188D02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042EA38-4DC5-4C02-882B-2E74CC8E73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804C4B8-556D-48E9-B449-4F37C521ED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3CE12F-B437-46C5-B3B7-3BE8C9A8D7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15B7C-E7FE-403B-803B-159376EDE386}" type="datetimeFigureOut">
              <a:rPr lang="en-US" smtClean="0"/>
              <a:t>10/15/2022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71E1B47-347C-4E82-A8A5-C4FC441BD5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5C386CC-01CA-47DF-8108-4268FD2A0A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2C32-8ACE-48A5-8DCA-DCA24D225D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58133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5CA1C2-DE66-4084-B87A-83C8716297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370339A-87A3-4725-88F4-D046E16882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15B7C-E7FE-403B-803B-159376EDE386}" type="datetimeFigureOut">
              <a:rPr lang="en-US" smtClean="0"/>
              <a:t>10/15/2022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4A5B2A8-C1F5-4415-8C20-35670C053C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C993C2B-6FBA-4A83-B764-FA9BD5B93D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2C32-8ACE-48A5-8DCA-DCA24D225D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1264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30E70BE-C299-4DD5-8539-B955F6006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15B7C-E7FE-403B-803B-159376EDE386}" type="datetimeFigureOut">
              <a:rPr lang="en-US" smtClean="0"/>
              <a:t>10/15/2022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39EB606-CC16-4D04-AB65-2977D8205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908B2E-74B9-4E38-B580-CB5BC90E5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2C32-8ACE-48A5-8DCA-DCA24D225D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2765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3E3CF5-1009-4822-A579-ABED2A4B3C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29F406-4C48-43E7-88F4-BC25CFE075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E7C5AE-9B98-409B-AB70-C16131BF9C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4ED3C4-8D44-4F58-AFF1-1C293A80D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15B7C-E7FE-403B-803B-159376EDE386}" type="datetimeFigureOut">
              <a:rPr lang="en-US" smtClean="0"/>
              <a:t>10/15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D4A72D-200C-4DA4-AFB4-7E5371A94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9B3B03-DB55-4FCE-9225-C10A99C6E3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2C32-8ACE-48A5-8DCA-DCA24D225D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6315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264AA0-295C-4DDB-87E1-1E5AC527DA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B58306D-7E19-473D-8FA8-593CDD9B7A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B5EF3F-D2A7-49F2-B6DF-863C43C036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86AA78-34E3-4B39-AD73-21967078E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15B7C-E7FE-403B-803B-159376EDE386}" type="datetimeFigureOut">
              <a:rPr lang="en-US" smtClean="0"/>
              <a:t>10/15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0B1341-B6C7-4DE0-ABDA-5FBB78173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8F66D2-0A1F-4C03-914B-79F3F5C40C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2C32-8ACE-48A5-8DCA-DCA24D225D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33462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6BE5CC8-76A1-492A-99C3-1319E9576C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352E40-C0EC-4F17-905A-E3F4678214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F47B42-907F-4E34-A2D6-7ABB1233DC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B15B7C-E7FE-403B-803B-159376EDE386}" type="datetimeFigureOut">
              <a:rPr lang="en-US" smtClean="0"/>
              <a:t>10/15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F5ED11-CA65-40CA-9BB5-A2C46E66B1C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6D5638-D89A-447A-A162-9B943069C9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4A2C32-8ACE-48A5-8DCA-DCA24D225D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6258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Box 73">
            <a:extLst>
              <a:ext uri="{FF2B5EF4-FFF2-40B4-BE49-F238E27FC236}">
                <a16:creationId xmlns:a16="http://schemas.microsoft.com/office/drawing/2014/main" id="{F1D55191-A4B2-9B9B-0297-0F408C450F28}"/>
              </a:ext>
            </a:extLst>
          </p:cNvPr>
          <p:cNvSpPr txBox="1"/>
          <p:nvPr/>
        </p:nvSpPr>
        <p:spPr>
          <a:xfrm>
            <a:off x="1337501" y="3943655"/>
            <a:ext cx="943018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S1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ensitometry data for (A) pH2AX and (B) pRPA32 and (C) calculated fold change compared to vehicle, from the immunoblotting of SW620 cell lysates shown in Fig 4F.</a:t>
            </a:r>
          </a:p>
        </p:txBody>
      </p:sp>
      <p:graphicFrame>
        <p:nvGraphicFramePr>
          <p:cNvPr id="77" name="Object 76">
            <a:extLst>
              <a:ext uri="{FF2B5EF4-FFF2-40B4-BE49-F238E27FC236}">
                <a16:creationId xmlns:a16="http://schemas.microsoft.com/office/drawing/2014/main" id="{60EFCE1E-8E77-8232-A3F1-789FA6E00C6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252113"/>
              </p:ext>
            </p:extLst>
          </p:nvPr>
        </p:nvGraphicFramePr>
        <p:xfrm>
          <a:off x="1748802" y="1419649"/>
          <a:ext cx="1685258" cy="15912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9" r:id="rId3" imgW="2334040" imgH="2203062" progId="Prism9.Document">
                  <p:embed/>
                </p:oleObj>
              </mc:Choice>
              <mc:Fallback>
                <p:oleObj name="Prism 9" r:id="rId3" imgW="2334040" imgH="2203062" progId="Prism9.Document">
                  <p:embed/>
                  <p:pic>
                    <p:nvPicPr>
                      <p:cNvPr id="77" name="Object 76">
                        <a:extLst>
                          <a:ext uri="{FF2B5EF4-FFF2-40B4-BE49-F238E27FC236}">
                            <a16:creationId xmlns:a16="http://schemas.microsoft.com/office/drawing/2014/main" id="{60EFCE1E-8E77-8232-A3F1-789FA6E00C6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48802" y="1419649"/>
                        <a:ext cx="1685258" cy="15912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8" name="TextBox 77">
            <a:extLst>
              <a:ext uri="{FF2B5EF4-FFF2-40B4-BE49-F238E27FC236}">
                <a16:creationId xmlns:a16="http://schemas.microsoft.com/office/drawing/2014/main" id="{2FB69A0A-88C4-F471-8306-9D61735CCF25}"/>
              </a:ext>
            </a:extLst>
          </p:cNvPr>
          <p:cNvSpPr txBox="1"/>
          <p:nvPr/>
        </p:nvSpPr>
        <p:spPr>
          <a:xfrm rot="16200000">
            <a:off x="1085625" y="2178347"/>
            <a:ext cx="11945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H2AX/β-Actin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FFDD4869-589A-E317-CF1D-285B12CB5D95}"/>
              </a:ext>
            </a:extLst>
          </p:cNvPr>
          <p:cNvSpPr txBox="1"/>
          <p:nvPr/>
        </p:nvSpPr>
        <p:spPr>
          <a:xfrm rot="16200000">
            <a:off x="1866261" y="3154089"/>
            <a:ext cx="609535" cy="265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1DDA161D-C143-BD9C-A6A0-1C05DAE10411}"/>
              </a:ext>
            </a:extLst>
          </p:cNvPr>
          <p:cNvSpPr txBox="1"/>
          <p:nvPr/>
        </p:nvSpPr>
        <p:spPr>
          <a:xfrm rot="16200000">
            <a:off x="2199134" y="3253739"/>
            <a:ext cx="808830" cy="265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spalathin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3BF002C3-97F1-8C1C-2E9B-578EE5E74FBC}"/>
              </a:ext>
            </a:extLst>
          </p:cNvPr>
          <p:cNvSpPr txBox="1"/>
          <p:nvPr/>
        </p:nvSpPr>
        <p:spPr>
          <a:xfrm rot="16200000">
            <a:off x="2109484" y="3131233"/>
            <a:ext cx="563819" cy="265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BRD9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90769730-631D-8606-E771-2022BEF8182D}"/>
              </a:ext>
            </a:extLst>
          </p:cNvPr>
          <p:cNvSpPr txBox="1"/>
          <p:nvPr/>
        </p:nvSpPr>
        <p:spPr>
          <a:xfrm rot="16200000">
            <a:off x="2522703" y="3136276"/>
            <a:ext cx="573906" cy="265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GCG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C8B63F6B-9C3A-B4F3-B184-DCE66DAABF25}"/>
              </a:ext>
            </a:extLst>
          </p:cNvPr>
          <p:cNvSpPr txBox="1"/>
          <p:nvPr/>
        </p:nvSpPr>
        <p:spPr>
          <a:xfrm rot="16200000">
            <a:off x="2631363" y="3231399"/>
            <a:ext cx="764152" cy="265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Quercetin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1CA8A6B6-BEF0-A5CA-C84D-40109C29FB1D}"/>
              </a:ext>
            </a:extLst>
          </p:cNvPr>
          <p:cNvSpPr txBox="1"/>
          <p:nvPr/>
        </p:nvSpPr>
        <p:spPr>
          <a:xfrm rot="16200000">
            <a:off x="2971611" y="3108172"/>
            <a:ext cx="517699" cy="265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quol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91E329F-6B3F-A348-8BAA-9C27D7C030A6}"/>
              </a:ext>
            </a:extLst>
          </p:cNvPr>
          <p:cNvSpPr txBox="1"/>
          <p:nvPr/>
        </p:nvSpPr>
        <p:spPr>
          <a:xfrm>
            <a:off x="3037555" y="1505637"/>
            <a:ext cx="368053" cy="221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720A935-40E2-48E2-B371-094DE0A98DBC}"/>
              </a:ext>
            </a:extLst>
          </p:cNvPr>
          <p:cNvSpPr txBox="1"/>
          <p:nvPr/>
        </p:nvSpPr>
        <p:spPr>
          <a:xfrm>
            <a:off x="2823432" y="1597572"/>
            <a:ext cx="368053" cy="221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F8F1D531-993B-B341-8D9B-795E98444121}"/>
              </a:ext>
            </a:extLst>
          </p:cNvPr>
          <p:cNvSpPr txBox="1"/>
          <p:nvPr/>
        </p:nvSpPr>
        <p:spPr>
          <a:xfrm>
            <a:off x="2600431" y="1699913"/>
            <a:ext cx="368053" cy="221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A18B01D0-F9DC-1709-7F70-BEB630A4E272}"/>
              </a:ext>
            </a:extLst>
          </p:cNvPr>
          <p:cNvSpPr txBox="1"/>
          <p:nvPr/>
        </p:nvSpPr>
        <p:spPr>
          <a:xfrm>
            <a:off x="2453539" y="2154691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8243326F-EB64-1E3F-70E3-9BF3C5C63164}"/>
              </a:ext>
            </a:extLst>
          </p:cNvPr>
          <p:cNvSpPr txBox="1"/>
          <p:nvPr/>
        </p:nvSpPr>
        <p:spPr>
          <a:xfrm>
            <a:off x="2225292" y="1898604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**</a:t>
            </a:r>
          </a:p>
        </p:txBody>
      </p:sp>
      <p:graphicFrame>
        <p:nvGraphicFramePr>
          <p:cNvPr id="91" name="Object 90">
            <a:extLst>
              <a:ext uri="{FF2B5EF4-FFF2-40B4-BE49-F238E27FC236}">
                <a16:creationId xmlns:a16="http://schemas.microsoft.com/office/drawing/2014/main" id="{CF5B7A08-1FB3-7E19-6057-C007BC44E5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2571537"/>
              </p:ext>
            </p:extLst>
          </p:nvPr>
        </p:nvGraphicFramePr>
        <p:xfrm>
          <a:off x="3961295" y="1389729"/>
          <a:ext cx="1774334" cy="16211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9" r:id="rId5" imgW="2390581" imgH="2184694" progId="Prism9.Document">
                  <p:embed/>
                </p:oleObj>
              </mc:Choice>
              <mc:Fallback>
                <p:oleObj name="Prism 9" r:id="rId5" imgW="2390581" imgH="2184694" progId="Prism9.Document">
                  <p:embed/>
                  <p:pic>
                    <p:nvPicPr>
                      <p:cNvPr id="91" name="Object 90">
                        <a:extLst>
                          <a:ext uri="{FF2B5EF4-FFF2-40B4-BE49-F238E27FC236}">
                            <a16:creationId xmlns:a16="http://schemas.microsoft.com/office/drawing/2014/main" id="{CF5B7A08-1FB3-7E19-6057-C007BC44E5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61295" y="1389729"/>
                        <a:ext cx="1774334" cy="16211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" name="TextBox 91">
            <a:extLst>
              <a:ext uri="{FF2B5EF4-FFF2-40B4-BE49-F238E27FC236}">
                <a16:creationId xmlns:a16="http://schemas.microsoft.com/office/drawing/2014/main" id="{0DD6A542-FB08-0FAC-5C3D-1D9EEF0AB985}"/>
              </a:ext>
            </a:extLst>
          </p:cNvPr>
          <p:cNvSpPr txBox="1"/>
          <p:nvPr/>
        </p:nvSpPr>
        <p:spPr>
          <a:xfrm rot="16200000">
            <a:off x="4123907" y="3130171"/>
            <a:ext cx="609535" cy="265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9E916DAB-737A-E80E-6111-94D1D327EB1F}"/>
              </a:ext>
            </a:extLst>
          </p:cNvPr>
          <p:cNvSpPr txBox="1"/>
          <p:nvPr/>
        </p:nvSpPr>
        <p:spPr>
          <a:xfrm rot="16200000">
            <a:off x="4456780" y="3229821"/>
            <a:ext cx="808830" cy="265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spalathin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62E05264-24FE-E299-8DB3-A8B8719C2C72}"/>
              </a:ext>
            </a:extLst>
          </p:cNvPr>
          <p:cNvSpPr txBox="1"/>
          <p:nvPr/>
        </p:nvSpPr>
        <p:spPr>
          <a:xfrm rot="16200000">
            <a:off x="4367130" y="3107315"/>
            <a:ext cx="563819" cy="265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BRD9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7C6BAD20-15D6-FF7D-DE2D-362F3C75AA71}"/>
              </a:ext>
            </a:extLst>
          </p:cNvPr>
          <p:cNvSpPr txBox="1"/>
          <p:nvPr/>
        </p:nvSpPr>
        <p:spPr>
          <a:xfrm rot="16200000">
            <a:off x="4780349" y="3112358"/>
            <a:ext cx="573906" cy="265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GCG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053954E4-1628-CA01-A0B4-DFDFE0BC1AA6}"/>
              </a:ext>
            </a:extLst>
          </p:cNvPr>
          <p:cNvSpPr txBox="1"/>
          <p:nvPr/>
        </p:nvSpPr>
        <p:spPr>
          <a:xfrm rot="16200000">
            <a:off x="4889009" y="3207481"/>
            <a:ext cx="764152" cy="265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Quercetin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D6016996-F09B-46B8-85FE-29C764D0ED26}"/>
              </a:ext>
            </a:extLst>
          </p:cNvPr>
          <p:cNvSpPr txBox="1"/>
          <p:nvPr/>
        </p:nvSpPr>
        <p:spPr>
          <a:xfrm rot="16200000">
            <a:off x="5229257" y="3084254"/>
            <a:ext cx="517699" cy="265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quol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51E76668-FCBD-693C-E73F-D7ADE1A446CE}"/>
              </a:ext>
            </a:extLst>
          </p:cNvPr>
          <p:cNvSpPr txBox="1"/>
          <p:nvPr/>
        </p:nvSpPr>
        <p:spPr>
          <a:xfrm rot="16200000">
            <a:off x="3253793" y="2149642"/>
            <a:ext cx="12681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RPA32/β-Actin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F1B920C7-D110-934F-4176-C58C474BE4E0}"/>
              </a:ext>
            </a:extLst>
          </p:cNvPr>
          <p:cNvSpPr txBox="1"/>
          <p:nvPr/>
        </p:nvSpPr>
        <p:spPr>
          <a:xfrm>
            <a:off x="4536216" y="176132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3543B96A-B945-DC17-C08A-0910A0968DC1}"/>
              </a:ext>
            </a:extLst>
          </p:cNvPr>
          <p:cNvSpPr txBox="1"/>
          <p:nvPr/>
        </p:nvSpPr>
        <p:spPr>
          <a:xfrm>
            <a:off x="5393395" y="203944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15EC15F8-D8CA-F8DF-523A-8A3C913DA5C2}"/>
              </a:ext>
            </a:extLst>
          </p:cNvPr>
          <p:cNvSpPr txBox="1"/>
          <p:nvPr/>
        </p:nvSpPr>
        <p:spPr>
          <a:xfrm>
            <a:off x="4706613" y="1701304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D50A758A-E0F6-AE6F-894D-A5C9390327D8}"/>
              </a:ext>
            </a:extLst>
          </p:cNvPr>
          <p:cNvSpPr txBox="1"/>
          <p:nvPr/>
        </p:nvSpPr>
        <p:spPr>
          <a:xfrm>
            <a:off x="3600474" y="1075411"/>
            <a:ext cx="361864" cy="249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D71483E8-FC33-AAE3-D7B0-61C1727B8833}"/>
              </a:ext>
            </a:extLst>
          </p:cNvPr>
          <p:cNvSpPr txBox="1"/>
          <p:nvPr/>
        </p:nvSpPr>
        <p:spPr>
          <a:xfrm>
            <a:off x="1337501" y="1075411"/>
            <a:ext cx="361864" cy="249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104" name="Table 103">
            <a:extLst>
              <a:ext uri="{FF2B5EF4-FFF2-40B4-BE49-F238E27FC236}">
                <a16:creationId xmlns:a16="http://schemas.microsoft.com/office/drawing/2014/main" id="{A4EE376E-7B29-FC03-3280-43C38939B7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7985171"/>
              </p:ext>
            </p:extLst>
          </p:nvPr>
        </p:nvGraphicFramePr>
        <p:xfrm>
          <a:off x="5978435" y="1584603"/>
          <a:ext cx="4789251" cy="1348089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697715">
                  <a:extLst>
                    <a:ext uri="{9D8B030D-6E8A-4147-A177-3AD203B41FA5}">
                      <a16:colId xmlns:a16="http://schemas.microsoft.com/office/drawing/2014/main" val="1558259063"/>
                    </a:ext>
                  </a:extLst>
                </a:gridCol>
                <a:gridCol w="577121">
                  <a:extLst>
                    <a:ext uri="{9D8B030D-6E8A-4147-A177-3AD203B41FA5}">
                      <a16:colId xmlns:a16="http://schemas.microsoft.com/office/drawing/2014/main" val="784947646"/>
                    </a:ext>
                  </a:extLst>
                </a:gridCol>
                <a:gridCol w="740784">
                  <a:extLst>
                    <a:ext uri="{9D8B030D-6E8A-4147-A177-3AD203B41FA5}">
                      <a16:colId xmlns:a16="http://schemas.microsoft.com/office/drawing/2014/main" val="595597330"/>
                    </a:ext>
                  </a:extLst>
                </a:gridCol>
                <a:gridCol w="801079">
                  <a:extLst>
                    <a:ext uri="{9D8B030D-6E8A-4147-A177-3AD203B41FA5}">
                      <a16:colId xmlns:a16="http://schemas.microsoft.com/office/drawing/2014/main" val="1524735967"/>
                    </a:ext>
                  </a:extLst>
                </a:gridCol>
                <a:gridCol w="680487">
                  <a:extLst>
                    <a:ext uri="{9D8B030D-6E8A-4147-A177-3AD203B41FA5}">
                      <a16:colId xmlns:a16="http://schemas.microsoft.com/office/drawing/2014/main" val="276065192"/>
                    </a:ext>
                  </a:extLst>
                </a:gridCol>
                <a:gridCol w="740784">
                  <a:extLst>
                    <a:ext uri="{9D8B030D-6E8A-4147-A177-3AD203B41FA5}">
                      <a16:colId xmlns:a16="http://schemas.microsoft.com/office/drawing/2014/main" val="4057837793"/>
                    </a:ext>
                  </a:extLst>
                </a:gridCol>
                <a:gridCol w="551281">
                  <a:extLst>
                    <a:ext uri="{9D8B030D-6E8A-4147-A177-3AD203B41FA5}">
                      <a16:colId xmlns:a16="http://schemas.microsoft.com/office/drawing/2014/main" val="1591395830"/>
                    </a:ext>
                  </a:extLst>
                </a:gridCol>
              </a:tblGrid>
              <a:tr h="274770"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Fold change based on densitometry data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38501526"/>
                  </a:ext>
                </a:extLst>
              </a:tr>
              <a:tr h="292395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Vehicl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iBrd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  <a:latin typeface="Arial"/>
                        </a:rPr>
                        <a:t>Aspalath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EGC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Quercet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  <a:latin typeface="Arial"/>
                        </a:rPr>
                        <a:t>Equo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6423014"/>
                  </a:ext>
                </a:extLst>
              </a:tr>
              <a:tr h="3904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pH2AX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1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3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2.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4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5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6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2100939"/>
                  </a:ext>
                </a:extLst>
              </a:tr>
              <a:tr h="3904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pRPA32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1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2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2.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1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1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</a:rPr>
                        <a:t>1.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5994100"/>
                  </a:ext>
                </a:extLst>
              </a:tr>
            </a:tbl>
          </a:graphicData>
        </a:graphic>
      </p:graphicFrame>
      <p:sp>
        <p:nvSpPr>
          <p:cNvPr id="105" name="TextBox 104">
            <a:extLst>
              <a:ext uri="{FF2B5EF4-FFF2-40B4-BE49-F238E27FC236}">
                <a16:creationId xmlns:a16="http://schemas.microsoft.com/office/drawing/2014/main" id="{E1128D0E-B732-AD9A-2F88-83B1979BC8C7}"/>
              </a:ext>
            </a:extLst>
          </p:cNvPr>
          <p:cNvSpPr txBox="1"/>
          <p:nvPr/>
        </p:nvSpPr>
        <p:spPr>
          <a:xfrm>
            <a:off x="5735629" y="1075411"/>
            <a:ext cx="361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9105218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Box 52">
            <a:extLst>
              <a:ext uri="{FF2B5EF4-FFF2-40B4-BE49-F238E27FC236}">
                <a16:creationId xmlns:a16="http://schemas.microsoft.com/office/drawing/2014/main" id="{73AFEBC7-96D4-44BC-8FAB-B6A1356AB8B4}"/>
              </a:ext>
            </a:extLst>
          </p:cNvPr>
          <p:cNvSpPr txBox="1"/>
          <p:nvPr/>
        </p:nvSpPr>
        <p:spPr>
          <a:xfrm>
            <a:off x="4129589" y="4423831"/>
            <a:ext cx="353794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Table S1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Bromodomain inhibition. Bromoscan™ screening at 10 µM of test agent;   – not determined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F0795DF-93A0-26A0-896E-E44CC359AEC2}"/>
              </a:ext>
            </a:extLst>
          </p:cNvPr>
          <p:cNvGraphicFramePr>
            <a:graphicFrameLocks noGrp="1"/>
          </p:cNvGraphicFramePr>
          <p:nvPr/>
        </p:nvGraphicFramePr>
        <p:xfrm>
          <a:off x="4163145" y="954793"/>
          <a:ext cx="3404464" cy="334037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910510">
                  <a:extLst>
                    <a:ext uri="{9D8B030D-6E8A-4147-A177-3AD203B41FA5}">
                      <a16:colId xmlns:a16="http://schemas.microsoft.com/office/drawing/2014/main" val="2018251931"/>
                    </a:ext>
                  </a:extLst>
                </a:gridCol>
                <a:gridCol w="750738">
                  <a:extLst>
                    <a:ext uri="{9D8B030D-6E8A-4147-A177-3AD203B41FA5}">
                      <a16:colId xmlns:a16="http://schemas.microsoft.com/office/drawing/2014/main" val="2560954808"/>
                    </a:ext>
                  </a:extLst>
                </a:gridCol>
                <a:gridCol w="871608">
                  <a:extLst>
                    <a:ext uri="{9D8B030D-6E8A-4147-A177-3AD203B41FA5}">
                      <a16:colId xmlns:a16="http://schemas.microsoft.com/office/drawing/2014/main" val="4219866553"/>
                    </a:ext>
                  </a:extLst>
                </a:gridCol>
                <a:gridCol w="871608">
                  <a:extLst>
                    <a:ext uri="{9D8B030D-6E8A-4147-A177-3AD203B41FA5}">
                      <a16:colId xmlns:a16="http://schemas.microsoft.com/office/drawing/2014/main" val="838683335"/>
                    </a:ext>
                  </a:extLst>
                </a:gridCol>
              </a:tblGrid>
              <a:tr h="35243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ound</a:t>
                      </a:r>
                    </a:p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44" marR="3844" marT="3844" marB="0" anchor="b"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400" b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omodomain inhibition (%)</a:t>
                      </a:r>
                      <a:endParaRPr lang="en-US" sz="1100" b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44" marR="3844" marT="384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44" marR="3844" marT="384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44" marR="3844" marT="384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89114052"/>
                  </a:ext>
                </a:extLst>
              </a:tr>
              <a:tr h="303067">
                <a:tc vMerge="1"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mpound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44" marR="3844" marT="3844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D9 </a:t>
                      </a:r>
                    </a:p>
                  </a:txBody>
                  <a:tcPr marL="3844" marR="3844" marT="3844" marB="0" anchor="b"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D4</a:t>
                      </a:r>
                    </a:p>
                  </a:txBody>
                  <a:tcPr marL="3844" marR="3844" marT="3844" marB="0" anchor="b"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D7</a:t>
                      </a:r>
                    </a:p>
                  </a:txBody>
                  <a:tcPr marL="3844" marR="3844" marT="384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70325190"/>
                  </a:ext>
                </a:extLst>
              </a:tr>
              <a:tr h="2684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rienti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44" marR="3844" marT="38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2398493"/>
                  </a:ext>
                </a:extLst>
              </a:tr>
              <a:tr h="2684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GCG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44" marR="3844" marT="38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97472426"/>
                  </a:ext>
                </a:extLst>
              </a:tr>
              <a:tr h="26005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quol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44" marR="3844" marT="38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9263688"/>
                  </a:ext>
                </a:extLst>
              </a:tr>
              <a:tr h="2684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yperosid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44" marR="3844" marT="38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endParaRPr lang="en-US" sz="1200" b="0" i="0" u="none" strike="noStrike" dirty="0">
                        <a:solidFill>
                          <a:schemeClr val="bg2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2103001"/>
                  </a:ext>
                </a:extLst>
              </a:tr>
              <a:tr h="2684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Querceti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44" marR="3844" marT="38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endParaRPr lang="en-US" sz="1200" b="0" i="0" u="none" strike="noStrike" dirty="0">
                        <a:solidFill>
                          <a:schemeClr val="bg2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3564442"/>
                  </a:ext>
                </a:extLst>
              </a:tr>
              <a:tr h="2768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soorienti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44" marR="3844" marT="38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endParaRPr lang="en-US" sz="1200" b="0" i="0" u="none" strike="noStrike" dirty="0">
                        <a:solidFill>
                          <a:schemeClr val="bg2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5029283"/>
                  </a:ext>
                </a:extLst>
              </a:tr>
              <a:tr h="2768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palathi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44" marR="3844" marT="38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endParaRPr lang="en-US" sz="1200" b="0" i="0" u="none" strike="noStrike" dirty="0">
                        <a:solidFill>
                          <a:schemeClr val="bg2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766458"/>
                  </a:ext>
                </a:extLst>
              </a:tr>
              <a:tr h="2684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BRD9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44" marR="3844" marT="38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endParaRPr lang="en-US" sz="1200" b="0" i="0" u="none" strike="noStrike" dirty="0">
                        <a:solidFill>
                          <a:schemeClr val="bg2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6520502"/>
                  </a:ext>
                </a:extLst>
              </a:tr>
              <a:tr h="260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Q1</a:t>
                      </a:r>
                    </a:p>
                  </a:txBody>
                  <a:tcPr marL="3844" marR="3844" marT="38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endParaRPr lang="en-US" sz="1200" b="0" i="0" u="none" strike="noStrike" dirty="0">
                        <a:solidFill>
                          <a:schemeClr val="bg2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6901585"/>
                  </a:ext>
                </a:extLst>
              </a:tr>
              <a:tr h="2516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7273</a:t>
                      </a:r>
                    </a:p>
                  </a:txBody>
                  <a:tcPr marL="3844" marR="3844" marT="384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endParaRPr lang="en-US" sz="1200" b="0" i="0" u="none" strike="noStrike" dirty="0">
                        <a:solidFill>
                          <a:schemeClr val="bg2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</a:t>
                      </a: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46143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236509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6">
            <a:extLst>
              <a:ext uri="{FF2B5EF4-FFF2-40B4-BE49-F238E27FC236}">
                <a16:creationId xmlns:a16="http://schemas.microsoft.com/office/drawing/2014/main" id="{0A0AB616-0FCC-4D69-A1B0-93F835248BC5}"/>
              </a:ext>
            </a:extLst>
          </p:cNvPr>
          <p:cNvGraphicFramePr>
            <a:graphicFrameLocks noGrp="1"/>
          </p:cNvGraphicFramePr>
          <p:nvPr/>
        </p:nvGraphicFramePr>
        <p:xfrm>
          <a:off x="3403982" y="1724232"/>
          <a:ext cx="5497544" cy="239805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54964">
                  <a:extLst>
                    <a:ext uri="{9D8B030D-6E8A-4147-A177-3AD203B41FA5}">
                      <a16:colId xmlns:a16="http://schemas.microsoft.com/office/drawing/2014/main" val="3211512904"/>
                    </a:ext>
                  </a:extLst>
                </a:gridCol>
                <a:gridCol w="888516">
                  <a:extLst>
                    <a:ext uri="{9D8B030D-6E8A-4147-A177-3AD203B41FA5}">
                      <a16:colId xmlns:a16="http://schemas.microsoft.com/office/drawing/2014/main" val="3490874052"/>
                    </a:ext>
                  </a:extLst>
                </a:gridCol>
                <a:gridCol w="888516">
                  <a:extLst>
                    <a:ext uri="{9D8B030D-6E8A-4147-A177-3AD203B41FA5}">
                      <a16:colId xmlns:a16="http://schemas.microsoft.com/office/drawing/2014/main" val="929686155"/>
                    </a:ext>
                  </a:extLst>
                </a:gridCol>
                <a:gridCol w="888516">
                  <a:extLst>
                    <a:ext uri="{9D8B030D-6E8A-4147-A177-3AD203B41FA5}">
                      <a16:colId xmlns:a16="http://schemas.microsoft.com/office/drawing/2014/main" val="4279015113"/>
                    </a:ext>
                  </a:extLst>
                </a:gridCol>
                <a:gridCol w="888516">
                  <a:extLst>
                    <a:ext uri="{9D8B030D-6E8A-4147-A177-3AD203B41FA5}">
                      <a16:colId xmlns:a16="http://schemas.microsoft.com/office/drawing/2014/main" val="3934747741"/>
                    </a:ext>
                  </a:extLst>
                </a:gridCol>
                <a:gridCol w="888516">
                  <a:extLst>
                    <a:ext uri="{9D8B030D-6E8A-4147-A177-3AD203B41FA5}">
                      <a16:colId xmlns:a16="http://schemas.microsoft.com/office/drawing/2014/main" val="2108657819"/>
                    </a:ext>
                  </a:extLst>
                </a:gridCol>
              </a:tblGrid>
              <a:tr h="322076">
                <a:tc rowSpan="2">
                  <a:txBody>
                    <a:bodyPr/>
                    <a:lstStyle/>
                    <a:p>
                      <a:pPr algn="ctr"/>
                      <a:endParaRPr lang="en-US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ound</a:t>
                      </a:r>
                    </a:p>
                  </a:txBody>
                  <a:tcPr marL="64936" marR="64936" marT="32468" marB="32468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SW620</a:t>
                      </a:r>
                      <a:endParaRPr lang="en-US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936" marR="64936" marT="32468" marB="32468"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936" marR="64936" marT="32468" marB="3246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W480</a:t>
                      </a:r>
                    </a:p>
                  </a:txBody>
                  <a:tcPr marL="64936" marR="64936" marT="32468" marB="32468"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936" marR="64936" marT="32468" marB="3246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D841</a:t>
                      </a:r>
                    </a:p>
                  </a:txBody>
                  <a:tcPr marL="64936" marR="64936" marT="32468" marB="32468"/>
                </a:tc>
                <a:extLst>
                  <a:ext uri="{0D108BD9-81ED-4DB2-BD59-A6C34878D82A}">
                    <a16:rowId xmlns:a16="http://schemas.microsoft.com/office/drawing/2014/main" val="4210367145"/>
                  </a:ext>
                </a:extLst>
              </a:tr>
              <a:tr h="465602">
                <a:tc vMerge="1">
                  <a:txBody>
                    <a:bodyPr/>
                    <a:lstStyle/>
                    <a:p>
                      <a:pPr algn="ctr"/>
                      <a:endParaRPr lang="en-US" sz="1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bility </a:t>
                      </a:r>
                    </a:p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IC</a:t>
                      </a:r>
                      <a:r>
                        <a:rPr lang="en-US" sz="1200" b="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r>
                        <a:rPr lang="en-US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µM</a:t>
                      </a:r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ony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IC</a:t>
                      </a:r>
                      <a:r>
                        <a:rPr lang="en-US" sz="1200" b="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r>
                        <a:rPr lang="en-US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µM</a:t>
                      </a:r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bility </a:t>
                      </a:r>
                    </a:p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IC</a:t>
                      </a:r>
                      <a:r>
                        <a:rPr lang="en-US" sz="1200" b="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r>
                        <a:rPr lang="en-US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µM</a:t>
                      </a:r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ony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IC</a:t>
                      </a:r>
                      <a:r>
                        <a:rPr lang="en-US" sz="1200" b="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r>
                        <a:rPr lang="en-US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µM</a:t>
                      </a:r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bility </a:t>
                      </a:r>
                    </a:p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IC</a:t>
                      </a:r>
                      <a:r>
                        <a:rPr lang="en-US" sz="1200" b="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r>
                        <a:rPr lang="en-US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µM</a:t>
                      </a:r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4936" marR="64936" marT="32468" marB="32468"/>
                </a:tc>
                <a:extLst>
                  <a:ext uri="{0D108BD9-81ED-4DB2-BD59-A6C34878D82A}">
                    <a16:rowId xmlns:a16="http://schemas.microsoft.com/office/drawing/2014/main" val="1585346219"/>
                  </a:ext>
                </a:extLst>
              </a:tr>
              <a:tr h="322076"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palathin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120</a:t>
                      </a:r>
                      <a:endPara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4936" marR="64936" marT="32468" marB="32468"/>
                </a:tc>
                <a:extLst>
                  <a:ext uri="{0D108BD9-81ED-4DB2-BD59-A6C34878D82A}">
                    <a16:rowId xmlns:a16="http://schemas.microsoft.com/office/drawing/2014/main" val="1203454422"/>
                  </a:ext>
                </a:extLst>
              </a:tr>
              <a:tr h="32207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CG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120</a:t>
                      </a:r>
                      <a:endPara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4936" marR="64936" marT="32468" marB="32468"/>
                </a:tc>
                <a:extLst>
                  <a:ext uri="{0D108BD9-81ED-4DB2-BD59-A6C34878D82A}">
                    <a16:rowId xmlns:a16="http://schemas.microsoft.com/office/drawing/2014/main" val="3124819597"/>
                  </a:ext>
                </a:extLst>
              </a:tr>
              <a:tr h="32207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quol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120</a:t>
                      </a:r>
                      <a:endPara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4936" marR="64936" marT="32468" marB="32468"/>
                </a:tc>
                <a:extLst>
                  <a:ext uri="{0D108BD9-81ED-4DB2-BD59-A6C34878D82A}">
                    <a16:rowId xmlns:a16="http://schemas.microsoft.com/office/drawing/2014/main" val="163233688"/>
                  </a:ext>
                </a:extLst>
              </a:tr>
              <a:tr h="32207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uercetin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/>
                          <a:cs typeface="Arial"/>
                        </a:rPr>
                        <a:t>35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/>
                          <a:cs typeface="Arial"/>
                        </a:rPr>
                        <a:t>24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/>
                          <a:cs typeface="Arial"/>
                        </a:rPr>
                        <a:t>45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/>
                          <a:cs typeface="Arial"/>
                        </a:rPr>
                        <a:t>41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1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  <a:latin typeface="Arial"/>
                          <a:cs typeface="Arial"/>
                        </a:rPr>
                        <a:t>&gt;120</a:t>
                      </a:r>
                      <a:endPara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effectLst/>
                        <a:uLnTx/>
                        <a:uFillTx/>
                        <a:latin typeface="Arial"/>
                        <a:ea typeface="+mn-ea"/>
                        <a:cs typeface="Arial"/>
                      </a:endParaRPr>
                    </a:p>
                  </a:txBody>
                  <a:tcPr marL="64936" marR="64936" marT="32468" marB="32468"/>
                </a:tc>
                <a:extLst>
                  <a:ext uri="{0D108BD9-81ED-4DB2-BD59-A6C34878D82A}">
                    <a16:rowId xmlns:a16="http://schemas.microsoft.com/office/drawing/2014/main" val="2018437383"/>
                  </a:ext>
                </a:extLst>
              </a:tr>
              <a:tr h="32207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BRD9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64936" marR="64936" marT="32468" marB="32468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30</a:t>
                      </a:r>
                    </a:p>
                  </a:txBody>
                  <a:tcPr marL="64936" marR="64936" marT="32468" marB="32468"/>
                </a:tc>
                <a:extLst>
                  <a:ext uri="{0D108BD9-81ED-4DB2-BD59-A6C34878D82A}">
                    <a16:rowId xmlns:a16="http://schemas.microsoft.com/office/drawing/2014/main" val="126487956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044B061-32D1-471C-80DB-F286F23B6631}"/>
              </a:ext>
            </a:extLst>
          </p:cNvPr>
          <p:cNvSpPr txBox="1"/>
          <p:nvPr/>
        </p:nvSpPr>
        <p:spPr>
          <a:xfrm>
            <a:off x="3290714" y="4202580"/>
            <a:ext cx="561081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Table S2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centration for 50% inhibition (IC</a:t>
            </a:r>
            <a:r>
              <a:rPr kumimoji="0" lang="en-US" sz="12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0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values in colon cancer (SW620, SW480) and normal colonic epithelial cells (CCD841) after 72 h of treatment, based on cell viability and colony formation assays as in Figs 4A,B.</a:t>
            </a:r>
            <a:endParaRPr kumimoji="0" 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45310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0E4CF1CF3D2E44C9EBC5F33876394C9" ma:contentTypeVersion="12" ma:contentTypeDescription="Create a new document." ma:contentTypeScope="" ma:versionID="97741f2d0785c2288820887c43c60d10">
  <xsd:schema xmlns:xsd="http://www.w3.org/2001/XMLSchema" xmlns:xs="http://www.w3.org/2001/XMLSchema" xmlns:p="http://schemas.microsoft.com/office/2006/metadata/properties" xmlns:ns3="53d305c0-d556-4442-a692-6052d30ee605" xmlns:ns4="d29b6bf5-79a5-478d-a422-0398f5d89ba4" targetNamespace="http://schemas.microsoft.com/office/2006/metadata/properties" ma:root="true" ma:fieldsID="8b7669f68500a6cfc515690287e5ba37" ns3:_="" ns4:_="">
    <xsd:import namespace="53d305c0-d556-4442-a692-6052d30ee605"/>
    <xsd:import namespace="d29b6bf5-79a5-478d-a422-0398f5d89ba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3d305c0-d556-4442-a692-6052d30ee60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29b6bf5-79a5-478d-a422-0398f5d89ba4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E905E3B-ED07-4D6D-8F9C-246CA3C82C3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3d305c0-d556-4442-a692-6052d30ee605"/>
    <ds:schemaRef ds:uri="d29b6bf5-79a5-478d-a422-0398f5d89ba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FBAA8F5-8CB1-4F28-8F96-BC42B68C7AFD}">
  <ds:schemaRefs>
    <ds:schemaRef ds:uri="http://purl.org/dc/terms/"/>
    <ds:schemaRef ds:uri="http://www.w3.org/XML/1998/namespace"/>
    <ds:schemaRef ds:uri="http://purl.org/dc/dcmitype/"/>
    <ds:schemaRef ds:uri="http://schemas.microsoft.com/office/2006/metadata/properties"/>
    <ds:schemaRef ds:uri="http://schemas.microsoft.com/office/infopath/2007/PartnerControls"/>
    <ds:schemaRef ds:uri="53d305c0-d556-4442-a692-6052d30ee605"/>
    <ds:schemaRef ds:uri="d29b6bf5-79a5-478d-a422-0398f5d89ba4"/>
    <ds:schemaRef ds:uri="http://schemas.microsoft.com/office/2006/documentManagement/types"/>
    <ds:schemaRef ds:uri="http://schemas.openxmlformats.org/package/2006/metadata/core-properties"/>
    <ds:schemaRef ds:uri="http://purl.org/dc/elements/1.1/"/>
  </ds:schemaRefs>
</ds:datastoreItem>
</file>

<file path=customXml/itemProps3.xml><?xml version="1.0" encoding="utf-8"?>
<ds:datastoreItem xmlns:ds="http://schemas.openxmlformats.org/officeDocument/2006/customXml" ds:itemID="{0C942BEA-54E9-44C6-BAB9-B6FFED8C9C6D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8586</TotalTime>
  <Words>284</Words>
  <Application>Microsoft Office PowerPoint</Application>
  <PresentationFormat>Widescreen</PresentationFormat>
  <Paragraphs>141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poor, Sabeeta</dc:creator>
  <cp:lastModifiedBy>MDPI</cp:lastModifiedBy>
  <cp:revision>116</cp:revision>
  <dcterms:created xsi:type="dcterms:W3CDTF">2022-02-08T20:15:15Z</dcterms:created>
  <dcterms:modified xsi:type="dcterms:W3CDTF">2022-10-15T09:06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0E4CF1CF3D2E44C9EBC5F33876394C9</vt:lpwstr>
  </property>
</Properties>
</file>